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0D0"/>
    <a:srgbClr val="A28B8A"/>
    <a:srgbClr val="4E211E"/>
    <a:srgbClr val="F5DFE0"/>
    <a:srgbClr val="E8B0B1"/>
    <a:srgbClr val="D967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218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63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88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293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974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635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380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298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165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037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077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CE0D28-4834-4F5F-9AB1-3D7C917536DB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D4CD-3F31-420E-B687-AE4524C75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871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F18C6D7E-D455-4BFA-85ED-14608949B8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3286922"/>
              </p:ext>
            </p:extLst>
          </p:nvPr>
        </p:nvGraphicFramePr>
        <p:xfrm>
          <a:off x="238124" y="731918"/>
          <a:ext cx="6381753" cy="822445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98158">
                  <a:extLst>
                    <a:ext uri="{9D8B030D-6E8A-4147-A177-3AD203B41FA5}">
                      <a16:colId xmlns:a16="http://schemas.microsoft.com/office/drawing/2014/main" val="2318423464"/>
                    </a:ext>
                  </a:extLst>
                </a:gridCol>
                <a:gridCol w="698158">
                  <a:extLst>
                    <a:ext uri="{9D8B030D-6E8A-4147-A177-3AD203B41FA5}">
                      <a16:colId xmlns:a16="http://schemas.microsoft.com/office/drawing/2014/main" val="2005686189"/>
                    </a:ext>
                  </a:extLst>
                </a:gridCol>
                <a:gridCol w="2890963">
                  <a:extLst>
                    <a:ext uri="{9D8B030D-6E8A-4147-A177-3AD203B41FA5}">
                      <a16:colId xmlns:a16="http://schemas.microsoft.com/office/drawing/2014/main" val="3098874518"/>
                    </a:ext>
                  </a:extLst>
                </a:gridCol>
                <a:gridCol w="698158">
                  <a:extLst>
                    <a:ext uri="{9D8B030D-6E8A-4147-A177-3AD203B41FA5}">
                      <a16:colId xmlns:a16="http://schemas.microsoft.com/office/drawing/2014/main" val="4006104373"/>
                    </a:ext>
                  </a:extLst>
                </a:gridCol>
                <a:gridCol w="698158">
                  <a:extLst>
                    <a:ext uri="{9D8B030D-6E8A-4147-A177-3AD203B41FA5}">
                      <a16:colId xmlns:a16="http://schemas.microsoft.com/office/drawing/2014/main" val="3639811074"/>
                    </a:ext>
                  </a:extLst>
                </a:gridCol>
                <a:gridCol w="698158">
                  <a:extLst>
                    <a:ext uri="{9D8B030D-6E8A-4147-A177-3AD203B41FA5}">
                      <a16:colId xmlns:a16="http://schemas.microsoft.com/office/drawing/2014/main" val="2593787262"/>
                    </a:ext>
                  </a:extLst>
                </a:gridCol>
              </a:tblGrid>
              <a:tr h="73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ie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 (Tumor vs Matched Norma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US" sz="1000" b="1" u="none" strike="noStrike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Tumor vs Matched Norma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valu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2080537"/>
                  </a:ext>
                </a:extLst>
              </a:tr>
              <a:tr h="182880">
                <a:tc rowSpan="1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s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D967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1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I) cha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1E-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8662101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4A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IV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9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5E-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213713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4A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2(IV) cha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4E-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212025165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6A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VI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9E-7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2068248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6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2(VI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2E-7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067488848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6A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3(VI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1.00E-25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794640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6A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6(VI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5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E-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214931752"/>
                  </a:ext>
                </a:extLst>
              </a:tr>
              <a:tr h="177732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7A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VII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2E-3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1159527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12A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XII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E-2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45566485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14A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XIV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5E-8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312121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15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XV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4E-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1725858059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18A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XVIII) cha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6E-3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4343645"/>
                  </a:ext>
                </a:extLst>
              </a:tr>
              <a:tr h="182880">
                <a:tc rowSpan="29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M glycoproteins</a:t>
                      </a:r>
                    </a:p>
                  </a:txBody>
                  <a:tcPr marL="3418" marR="3418" marT="3418" marB="0" vert="vert270" anchor="ctr">
                    <a:solidFill>
                      <a:srgbClr val="E8B0B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I3B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of Nesh-SH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7E-1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4370208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rmatopont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6E-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033938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LN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ulin-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3195480943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LN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ulin-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4E-1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779010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rinogen gamma cha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3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3320654516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A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inin subunit alpha-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6E-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322112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A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inin subunit alpha-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7E-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530720360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A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inin subunit alpha-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8E-17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2425749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inin subunit beta-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7E-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241632563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B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inin subunit beta-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6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1E-13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1752725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B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inin subunit beta-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E-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3284102632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C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inin subunit gamma-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4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5E-1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8794569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minin subunit gamma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7E-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4063722352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N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rilin-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4E-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579185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FAP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fibril-associated glycoprotein 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1E-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619058565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RN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ltimerin-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3E-0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6325010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RN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ltimerin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0E-1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59268952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D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dogen-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8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6E-9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4148296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PL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pil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8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65593199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iost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9E-6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045773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N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ndin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3E-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562396510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B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forming growth factor-beta-induced protein ig-h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6E-1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1808649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BS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rombospondin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1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4226124746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NAGL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ulointerstitial nephritis antigen-lik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8E-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6857365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nasc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7E-6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514417618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X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nascin-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3E-5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438543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rone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1E-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1851628028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WA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n Willebrand factor A domain-containing protein 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2E-3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084118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W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n Willebrand facto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8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E-4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b"/>
                </a:tc>
                <a:extLst>
                  <a:ext uri="{0D108BD9-81ED-4DB2-BD59-A6C34878D82A}">
                    <a16:rowId xmlns:a16="http://schemas.microsoft.com/office/drawing/2014/main" val="2641094131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D8613E8A-BF3F-46D9-952C-C4923DE86399}"/>
              </a:ext>
            </a:extLst>
          </p:cNvPr>
          <p:cNvSpPr txBox="1"/>
          <p:nvPr/>
        </p:nvSpPr>
        <p:spPr>
          <a:xfrm>
            <a:off x="324756" y="268057"/>
            <a:ext cx="44087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</p:spTree>
    <p:extLst>
      <p:ext uri="{BB962C8B-B14F-4D97-AF65-F5344CB8AC3E}">
        <p14:creationId xmlns:p14="http://schemas.microsoft.com/office/powerpoint/2010/main" val="21935719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F18C6D7E-D455-4BFA-85ED-14608949B8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1377179"/>
              </p:ext>
            </p:extLst>
          </p:nvPr>
        </p:nvGraphicFramePr>
        <p:xfrm>
          <a:off x="238123" y="731918"/>
          <a:ext cx="6381753" cy="538686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98158">
                  <a:extLst>
                    <a:ext uri="{9D8B030D-6E8A-4147-A177-3AD203B41FA5}">
                      <a16:colId xmlns:a16="http://schemas.microsoft.com/office/drawing/2014/main" val="3319467571"/>
                    </a:ext>
                  </a:extLst>
                </a:gridCol>
                <a:gridCol w="698158">
                  <a:extLst>
                    <a:ext uri="{9D8B030D-6E8A-4147-A177-3AD203B41FA5}">
                      <a16:colId xmlns:a16="http://schemas.microsoft.com/office/drawing/2014/main" val="2005686189"/>
                    </a:ext>
                  </a:extLst>
                </a:gridCol>
                <a:gridCol w="2890963">
                  <a:extLst>
                    <a:ext uri="{9D8B030D-6E8A-4147-A177-3AD203B41FA5}">
                      <a16:colId xmlns:a16="http://schemas.microsoft.com/office/drawing/2014/main" val="3098874518"/>
                    </a:ext>
                  </a:extLst>
                </a:gridCol>
                <a:gridCol w="698158">
                  <a:extLst>
                    <a:ext uri="{9D8B030D-6E8A-4147-A177-3AD203B41FA5}">
                      <a16:colId xmlns:a16="http://schemas.microsoft.com/office/drawing/2014/main" val="4006104373"/>
                    </a:ext>
                  </a:extLst>
                </a:gridCol>
                <a:gridCol w="698158">
                  <a:extLst>
                    <a:ext uri="{9D8B030D-6E8A-4147-A177-3AD203B41FA5}">
                      <a16:colId xmlns:a16="http://schemas.microsoft.com/office/drawing/2014/main" val="3639811074"/>
                    </a:ext>
                  </a:extLst>
                </a:gridCol>
                <a:gridCol w="698158">
                  <a:extLst>
                    <a:ext uri="{9D8B030D-6E8A-4147-A177-3AD203B41FA5}">
                      <a16:colId xmlns:a16="http://schemas.microsoft.com/office/drawing/2014/main" val="2593787262"/>
                    </a:ext>
                  </a:extLst>
                </a:gridCol>
              </a:tblGrid>
              <a:tr h="73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ies</a:t>
                      </a: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 (Tumor vs Matched Norma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US" sz="1000" b="1" u="none" strike="noStrike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Tumor vs Matched Norma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valu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8" marR="3418" marT="34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2080537"/>
                  </a:ext>
                </a:extLst>
              </a:tr>
              <a:tr h="182880">
                <a:tc rowSpan="8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oglycans</a:t>
                      </a:r>
                    </a:p>
                  </a:txBody>
                  <a:tcPr marL="4763" marR="4763" marT="4763" marB="0" vert="vert27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5DF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N</a:t>
                      </a:r>
                    </a:p>
                  </a:txBody>
                  <a:tcPr marL="4763" marR="4763" marT="47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or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4763" marR="4763" marT="47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7</a:t>
                      </a:r>
                    </a:p>
                  </a:txBody>
                  <a:tcPr marL="4763" marR="4763" marT="47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2E-09</a:t>
                      </a:r>
                    </a:p>
                  </a:txBody>
                  <a:tcPr marL="4763" marR="4763" marT="47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8662101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N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glyc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6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5E-5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213713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N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cor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7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4E-30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212025165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G2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ment membrane-specific heparan sulfate proteoglycan core protein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6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1.00E-253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2068248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ic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48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7E-27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067488848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GN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mecan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4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0E-41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794640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LP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argin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4E-27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214931752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oglycan 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1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8E-08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1159527"/>
                  </a:ext>
                </a:extLst>
              </a:tr>
              <a:tr h="182880"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M-affiliated proteins</a:t>
                      </a:r>
                    </a:p>
                  </a:txBody>
                  <a:tcPr marL="4763" marR="4763" marT="4763" marB="0" vert="vert270" anchor="ctr">
                    <a:solidFill>
                      <a:srgbClr val="4E211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nexin A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6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7E-07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45566485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2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nexin A2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1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2E-42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312121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6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nexin A6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9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3E-06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725858059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ALS7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lectin-7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9E-0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4343645"/>
                  </a:ext>
                </a:extLst>
              </a:tr>
              <a:tr h="170022">
                <a:tc rowSpan="10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M regulators</a:t>
                      </a:r>
                    </a:p>
                  </a:txBody>
                  <a:tcPr marL="4763" marR="4763" marT="4763" marB="0" vert="vert270" anchor="ctr">
                    <a:solidFill>
                      <a:srgbClr val="A28B8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tensinogen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9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3E-04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4370208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P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AMBP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0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2E-26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033938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SB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hepsin B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7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E-05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195480943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G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idine-rich glycoprotein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2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4E-10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7790104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G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ninogen-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0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93E-04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320654516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9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rix metalloproteinase-9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1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7E-0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3221121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B5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 B5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0E-09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530720360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B6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 B6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5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4E-0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2425749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H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 H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5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4E-15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241632563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M2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-glutamine gamma-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myltransferase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7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3E-37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1752725"/>
                  </a:ext>
                </a:extLst>
              </a:tr>
              <a:tr h="182880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reted factors</a:t>
                      </a:r>
                    </a:p>
                  </a:txBody>
                  <a:tcPr marL="4763" marR="4763" marT="4763" marB="0" vert="vert270" anchor="ctr">
                    <a:solidFill>
                      <a:srgbClr val="D9D0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roblast growth factor 2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5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07E-07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284102632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00A11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S100-A11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0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E-14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8794569"/>
                  </a:ext>
                </a:extLst>
              </a:tr>
              <a:tr h="18288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00A9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S100-A9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1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9E-05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0637223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99064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555</Words>
  <Application>Microsoft Office PowerPoint</Application>
  <PresentationFormat>Letter Paper (8.5x11 in)</PresentationFormat>
  <Paragraphs>34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a Bons</dc:creator>
  <cp:lastModifiedBy>Joanna Bons</cp:lastModifiedBy>
  <cp:revision>6</cp:revision>
  <dcterms:created xsi:type="dcterms:W3CDTF">2022-07-25T16:06:51Z</dcterms:created>
  <dcterms:modified xsi:type="dcterms:W3CDTF">2022-07-27T21:51:38Z</dcterms:modified>
</cp:coreProperties>
</file>